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0080625" cy="5670550"/>
  <p:notesSz cx="7559675" cy="106918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34376B5-1BE5-934C-626A-267624E86DFF}" v="1" dt="2020-07-27T08:54:58.555"/>
    <p1510:client id="{66C677BB-888F-13F5-7828-E091A0095D51}" v="115" dt="2020-07-27T08:50:16.09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87"/>
  </p:normalViewPr>
  <p:slideViewPr>
    <p:cSldViewPr snapToGrid="0" snapToObjects="1">
      <p:cViewPr varScale="1">
        <p:scale>
          <a:sx n="126" d="100"/>
          <a:sy n="126" d="100"/>
        </p:scale>
        <p:origin x="87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aúl Castanera Andrés" userId="S::raul.castanera@unavarra.es::21465e0c-191f-4c0b-8344-8cd86ef4ab86" providerId="AD" clId="Web-{66C677BB-888F-13F5-7828-E091A0095D51}"/>
    <pc:docChg chg="modSld">
      <pc:chgData name="Raúl Castanera Andrés" userId="S::raul.castanera@unavarra.es::21465e0c-191f-4c0b-8344-8cd86ef4ab86" providerId="AD" clId="Web-{66C677BB-888F-13F5-7828-E091A0095D51}" dt="2020-07-27T08:50:16.097" v="111" actId="1076"/>
      <pc:docMkLst>
        <pc:docMk/>
      </pc:docMkLst>
      <pc:sldChg chg="addSp delSp modSp">
        <pc:chgData name="Raúl Castanera Andrés" userId="S::raul.castanera@unavarra.es::21465e0c-191f-4c0b-8344-8cd86ef4ab86" providerId="AD" clId="Web-{66C677BB-888F-13F5-7828-E091A0095D51}" dt="2020-07-27T08:50:16.097" v="111" actId="1076"/>
        <pc:sldMkLst>
          <pc:docMk/>
          <pc:sldMk cId="0" sldId="256"/>
        </pc:sldMkLst>
        <pc:spChg chg="add del">
          <ac:chgData name="Raúl Castanera Andrés" userId="S::raul.castanera@unavarra.es::21465e0c-191f-4c0b-8344-8cd86ef4ab86" providerId="AD" clId="Web-{66C677BB-888F-13F5-7828-E091A0095D51}" dt="2020-07-27T08:48:00.163" v="3"/>
          <ac:spMkLst>
            <pc:docMk/>
            <pc:sldMk cId="0" sldId="256"/>
            <ac:spMk id="2" creationId="{F4A4CCD9-5E92-4E0B-9769-A7CBE8E59B2F}"/>
          </ac:spMkLst>
        </pc:spChg>
        <pc:spChg chg="add mod">
          <ac:chgData name="Raúl Castanera Andrés" userId="S::raul.castanera@unavarra.es::21465e0c-191f-4c0b-8344-8cd86ef4ab86" providerId="AD" clId="Web-{66C677BB-888F-13F5-7828-E091A0095D51}" dt="2020-07-27T08:50:16.097" v="111" actId="1076"/>
          <ac:spMkLst>
            <pc:docMk/>
            <pc:sldMk cId="0" sldId="256"/>
            <ac:spMk id="3" creationId="{34C4545F-9714-463A-AB78-286908E07F5E}"/>
          </ac:spMkLst>
        </pc:spChg>
        <pc:graphicFrameChg chg="mod">
          <ac:chgData name="Raúl Castanera Andrés" userId="S::raul.castanera@unavarra.es::21465e0c-191f-4c0b-8344-8cd86ef4ab86" providerId="AD" clId="Web-{66C677BB-888F-13F5-7828-E091A0095D51}" dt="2020-07-27T08:48:20.462" v="21" actId="1076"/>
          <ac:graphicFrameMkLst>
            <pc:docMk/>
            <pc:sldMk cId="0" sldId="256"/>
            <ac:graphicFrameMk id="41" creationId="{00000000-0000-0000-0000-000000000000}"/>
          </ac:graphicFrameMkLst>
        </pc:graphicFrameChg>
      </pc:sldChg>
    </pc:docChg>
  </pc:docChgLst>
  <pc:docChgLst>
    <pc:chgData name="Raúl Castanera Andrés" userId="S::raul.castanera@unavarra.es::21465e0c-191f-4c0b-8344-8cd86ef4ab86" providerId="AD" clId="Web-{634376B5-1BE5-934C-626A-267624E86DFF}"/>
    <pc:docChg chg="modSld">
      <pc:chgData name="Raúl Castanera Andrés" userId="S::raul.castanera@unavarra.es::21465e0c-191f-4c0b-8344-8cd86ef4ab86" providerId="AD" clId="Web-{634376B5-1BE5-934C-626A-267624E86DFF}" dt="2020-07-27T08:55:12.242" v="4" actId="14100"/>
      <pc:docMkLst>
        <pc:docMk/>
      </pc:docMkLst>
      <pc:sldChg chg="delSp modSp">
        <pc:chgData name="Raúl Castanera Andrés" userId="S::raul.castanera@unavarra.es::21465e0c-191f-4c0b-8344-8cd86ef4ab86" providerId="AD" clId="Web-{634376B5-1BE5-934C-626A-267624E86DFF}" dt="2020-07-27T08:55:12.242" v="4" actId="14100"/>
        <pc:sldMkLst>
          <pc:docMk/>
          <pc:sldMk cId="0" sldId="256"/>
        </pc:sldMkLst>
        <pc:spChg chg="del">
          <ac:chgData name="Raúl Castanera Andrés" userId="S::raul.castanera@unavarra.es::21465e0c-191f-4c0b-8344-8cd86ef4ab86" providerId="AD" clId="Web-{634376B5-1BE5-934C-626A-267624E86DFF}" dt="2020-07-27T08:54:58.555" v="0"/>
          <ac:spMkLst>
            <pc:docMk/>
            <pc:sldMk cId="0" sldId="256"/>
            <ac:spMk id="3" creationId="{34C4545F-9714-463A-AB78-286908E07F5E}"/>
          </ac:spMkLst>
        </pc:spChg>
        <pc:graphicFrameChg chg="mod">
          <ac:chgData name="Raúl Castanera Andrés" userId="S::raul.castanera@unavarra.es::21465e0c-191f-4c0b-8344-8cd86ef4ab86" providerId="AD" clId="Web-{634376B5-1BE5-934C-626A-267624E86DFF}" dt="2020-07-27T08:55:12.242" v="4" actId="14100"/>
          <ac:graphicFrameMkLst>
            <pc:docMk/>
            <pc:sldMk cId="0" sldId="256"/>
            <ac:graphicFrameMk id="41" creationId="{00000000-0000-0000-0000-000000000000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1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label 0</c:f>
              <c:strCache>
                <c:ptCount val="1"/>
                <c:pt idx="0">
                  <c:v>Custom library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>
                <a:noFill/>
              </a:ln>
              <a:effectLst>
                <a:outerShdw blurRad="317500" algn="ctr" rotWithShape="0">
                  <a:prstClr val="black">
                    <a:alpha val="25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362A-4A98-8FD8-25B45303C524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>
                <a:noFill/>
              </a:ln>
              <a:effectLst>
                <a:outerShdw blurRad="317500" algn="ctr" rotWithShape="0">
                  <a:prstClr val="black">
                    <a:alpha val="25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362A-4A98-8FD8-25B45303C524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>
                <a:noFill/>
              </a:ln>
              <a:effectLst>
                <a:outerShdw blurRad="317500" algn="ctr" rotWithShape="0">
                  <a:prstClr val="black">
                    <a:alpha val="25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362A-4A98-8FD8-25B45303C524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>
                <a:noFill/>
              </a:ln>
              <a:effectLst>
                <a:outerShdw blurRad="317500" algn="ctr" rotWithShape="0">
                  <a:prstClr val="black">
                    <a:alpha val="25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362A-4A98-8FD8-25B45303C524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>
                <a:noFill/>
              </a:ln>
              <a:effectLst>
                <a:outerShdw blurRad="317500" algn="ctr" rotWithShape="0">
                  <a:prstClr val="black">
                    <a:alpha val="25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362A-4A98-8FD8-25B45303C524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>
                <a:noFill/>
              </a:ln>
              <a:effectLst>
                <a:outerShdw blurRad="317500" algn="ctr" rotWithShape="0">
                  <a:prstClr val="black">
                    <a:alpha val="25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362A-4A98-8FD8-25B45303C524}"/>
              </c:ext>
            </c:extLst>
          </c:dPt>
          <c:dLbls>
            <c:dLbl>
              <c:idx val="0"/>
              <c:dLblPos val="inEnd"/>
              <c:showLegendKey val="0"/>
              <c:showVal val="0"/>
              <c:showCatName val="0"/>
              <c:showSerName val="0"/>
              <c:showPercent val="1"/>
              <c:showBubbleSiz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362A-4A98-8FD8-25B45303C524}"/>
                </c:ext>
              </c:extLst>
            </c:dLbl>
            <c:dLbl>
              <c:idx val="1"/>
              <c:dLblPos val="inEnd"/>
              <c:showLegendKey val="0"/>
              <c:showVal val="0"/>
              <c:showCatName val="0"/>
              <c:showSerName val="0"/>
              <c:showPercent val="1"/>
              <c:showBubbleSiz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362A-4A98-8FD8-25B45303C524}"/>
                </c:ext>
              </c:extLst>
            </c:dLbl>
            <c:dLbl>
              <c:idx val="2"/>
              <c:dLblPos val="inEnd"/>
              <c:showLegendKey val="0"/>
              <c:showVal val="0"/>
              <c:showCatName val="0"/>
              <c:showSerName val="0"/>
              <c:showPercent val="1"/>
              <c:showBubbleSiz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362A-4A98-8FD8-25B45303C524}"/>
                </c:ext>
              </c:extLst>
            </c:dLbl>
            <c:dLbl>
              <c:idx val="3"/>
              <c:dLblPos val="inEnd"/>
              <c:showLegendKey val="0"/>
              <c:showVal val="0"/>
              <c:showCatName val="0"/>
              <c:showSerName val="0"/>
              <c:showPercent val="1"/>
              <c:showBubbleSiz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362A-4A98-8FD8-25B45303C524}"/>
                </c:ext>
              </c:extLst>
            </c:dLbl>
            <c:dLbl>
              <c:idx val="4"/>
              <c:dLblPos val="inEnd"/>
              <c:showLegendKey val="0"/>
              <c:showVal val="0"/>
              <c:showCatName val="0"/>
              <c:showSerName val="0"/>
              <c:showPercent val="1"/>
              <c:showBubbleSiz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362A-4A98-8FD8-25B45303C524}"/>
                </c:ext>
              </c:extLst>
            </c:dLbl>
            <c:dLbl>
              <c:idx val="5"/>
              <c:dLblPos val="inEnd"/>
              <c:showLegendKey val="0"/>
              <c:showVal val="0"/>
              <c:showCatName val="0"/>
              <c:showSerName val="0"/>
              <c:showPercent val="1"/>
              <c:showBubbleSiz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362A-4A98-8FD8-25B45303C52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1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en-ES"/>
              </a:p>
            </c:txPr>
            <c:dLblPos val="inEnd"/>
            <c:showLegendKey val="0"/>
            <c:showVal val="0"/>
            <c:showCatName val="0"/>
            <c:showSerName val="0"/>
            <c:showPercent val="1"/>
            <c:showBubbleSize val="1"/>
            <c:separator> </c:separator>
            <c:showLeaderLines val="0"/>
            <c:extLst>
              <c:ext xmlns:c15="http://schemas.microsoft.com/office/drawing/2012/chart" uri="{CE6537A1-D6FC-4f65-9D91-7224C49458BB}"/>
            </c:extLst>
          </c:dLbls>
          <c:cat>
            <c:strRef>
              <c:f>categories</c:f>
              <c:strCache>
                <c:ptCount val="6"/>
                <c:pt idx="0">
                  <c:v>DHX</c:v>
                </c:pt>
                <c:pt idx="1">
                  <c:v>DTX</c:v>
                </c:pt>
                <c:pt idx="2">
                  <c:v>MITE</c:v>
                </c:pt>
                <c:pt idx="3">
                  <c:v>RIX</c:v>
                </c:pt>
                <c:pt idx="4">
                  <c:v>RLX</c:v>
                </c:pt>
                <c:pt idx="5">
                  <c:v>RSX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6"/>
                <c:pt idx="0">
                  <c:v>29</c:v>
                </c:pt>
                <c:pt idx="1">
                  <c:v>168</c:v>
                </c:pt>
                <c:pt idx="2">
                  <c:v>400</c:v>
                </c:pt>
                <c:pt idx="3">
                  <c:v>104</c:v>
                </c:pt>
                <c:pt idx="4">
                  <c:v>112</c:v>
                </c:pt>
                <c:pt idx="5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362A-4A98-8FD8-25B45303C524}"/>
            </c:ext>
          </c:extLst>
        </c:ser>
        <c:dLbls>
          <c:dLblPos val="inEnd"/>
          <c:showLegendKey val="0"/>
          <c:showVal val="0"/>
          <c:showCatName val="0"/>
          <c:showSerName val="0"/>
          <c:showPercent val="1"/>
          <c:showBubbleSize val="0"/>
          <c:showLeaderLines val="0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solidFill>
          <a:schemeClr val="lt1">
            <a:alpha val="78000"/>
          </a:schemeClr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dk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ES"/>
        </a:p>
      </c:txPr>
    </c:legend>
    <c:plotVisOnly val="1"/>
    <c:dispBlanksAs val="zero"/>
    <c:showDLblsOverMax val="1"/>
  </c:chart>
  <c:spPr>
    <a:pattFill prst="dkDnDiag">
      <a:fgClr>
        <a:schemeClr val="lt1">
          <a:lumMod val="95000"/>
        </a:schemeClr>
      </a:fgClr>
      <a:bgClr>
        <a:schemeClr val="lt1"/>
      </a:bgClr>
    </a:pattFill>
    <a:ln w="9525" cap="flat" cmpd="sng" algn="ctr">
      <a:solidFill>
        <a:schemeClr val="dk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ES"/>
    </a:p>
  </c:txPr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61">
  <cs:axisTitle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categoryAxis>
  <cs:chartArea>
    <cs:lnRef idx="0"/>
    <cs:fillRef idx="0"/>
    <cs:effectRef idx="0"/>
    <cs:fontRef idx="minor">
      <a:schemeClr val="dk1"/>
    </cs:fontRef>
    <cs:spPr>
      <a:pattFill prst="dkDnDiag">
        <a:fgClr>
          <a:schemeClr val="lt1">
            <a:lumMod val="95000"/>
          </a:schemeClr>
        </a:fgClr>
        <a:bgClr>
          <a:schemeClr val="lt1"/>
        </a:bgClr>
      </a:patt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lt1"/>
    </cs:fontRef>
    <cs:defRPr sz="1197" b="1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>
          <a:alpha val="75000"/>
        </a:schemeClr>
      </a:solidFill>
      <a:ln w="9525"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317500" algn="ctr" rotWithShape="0">
          <a:prstClr val="black">
            <a:alpha val="25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20000"/>
          </a:prstClr>
        </a:outerShdw>
      </a:effectLst>
      <a:scene3d>
        <a:camera prst="orthographicFront"/>
        <a:lightRig rig="threePt" dir="t"/>
      </a:scene3d>
      <a:sp3d prstMaterial="matte"/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noFill/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dk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>
          <a:alpha val="78000"/>
        </a:schemeClr>
      </a:solidFill>
    </cs:spPr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65000"/>
        <a:lumOff val="35000"/>
      </a:schemeClr>
    </cs:fontRef>
    <cs:defRPr sz="2200" b="1" kern="120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164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504000" y="3044160"/>
            <a:ext cx="907164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504000" y="304416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5152680" y="304416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292068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3571200" y="1326600"/>
            <a:ext cx="292068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6638040" y="1326600"/>
            <a:ext cx="292068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504000" y="3044160"/>
            <a:ext cx="292068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3571200" y="3044160"/>
            <a:ext cx="292068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6638040" y="3044160"/>
            <a:ext cx="292068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04000" y="1326600"/>
            <a:ext cx="9071640" cy="32882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1640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04000" y="226080"/>
            <a:ext cx="9071640" cy="4388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504000" y="304416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5152680" y="304416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504000" y="3044160"/>
            <a:ext cx="9071640" cy="1568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640" cy="9464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r>
              <a:rPr lang="en-US" sz="4400" b="0" strike="noStrike" spc="-1">
                <a:latin typeface="Arial"/>
              </a:rPr>
              <a:t>Click to edit the title text format</a:t>
            </a:r>
          </a:p>
        </p:txBody>
      </p:sp>
      <p:sp>
        <p:nvSpPr>
          <p:cNvPr id="6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1640" cy="32882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3200" b="0" strike="noStrike" spc="-1"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800" b="0" strike="noStrike" spc="-1"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400" b="0" strike="noStrike" spc="-1"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000" b="0" strike="noStrike" spc="-1"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eventh Outline Level</a:t>
            </a:r>
          </a:p>
        </p:txBody>
      </p:sp>
      <p:sp>
        <p:nvSpPr>
          <p:cNvPr id="2" name="PlaceHolder 3"/>
          <p:cNvSpPr>
            <a:spLocks noGrp="1"/>
          </p:cNvSpPr>
          <p:nvPr>
            <p:ph type="dt"/>
          </p:nvPr>
        </p:nvSpPr>
        <p:spPr>
          <a:xfrm>
            <a:off x="504000" y="5165280"/>
            <a:ext cx="2348280" cy="39060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r>
              <a:rPr lang="en-US" sz="1400" b="0" strike="noStrike" spc="-1">
                <a:latin typeface="Times New Roman"/>
              </a:rPr>
              <a:t>&lt;date/time&gt;</a:t>
            </a:r>
          </a:p>
        </p:txBody>
      </p:sp>
      <p:sp>
        <p:nvSpPr>
          <p:cNvPr id="3" name="PlaceHolder 4"/>
          <p:cNvSpPr>
            <a:spLocks noGrp="1"/>
          </p:cNvSpPr>
          <p:nvPr>
            <p:ph type="ftr"/>
          </p:nvPr>
        </p:nvSpPr>
        <p:spPr>
          <a:xfrm>
            <a:off x="3447360" y="5165280"/>
            <a:ext cx="3195000" cy="39060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algn="ctr"/>
            <a:r>
              <a:rPr lang="en-US" sz="1400" b="0" strike="noStrike" spc="-1">
                <a:latin typeface="Times New Roman"/>
              </a:rPr>
              <a:t>&lt;footer&gt;</a:t>
            </a:r>
          </a:p>
        </p:txBody>
      </p:sp>
      <p:sp>
        <p:nvSpPr>
          <p:cNvPr id="4" name="PlaceHolder 5"/>
          <p:cNvSpPr>
            <a:spLocks noGrp="1"/>
          </p:cNvSpPr>
          <p:nvPr>
            <p:ph type="sldNum"/>
          </p:nvPr>
        </p:nvSpPr>
        <p:spPr>
          <a:xfrm>
            <a:off x="7227360" y="5165280"/>
            <a:ext cx="2348280" cy="39060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algn="r"/>
            <a:fld id="{1CB3436A-89BE-4AAB-9E3A-CA4552237E42}" type="slidenum">
              <a:rPr lang="en-US" sz="1400" b="0" strike="noStrike" spc="-1">
                <a:latin typeface="Times New Roman"/>
              </a:rPr>
              <a:t>‹#›</a:t>
            </a:fld>
            <a:endParaRPr lang="en-US" sz="1400" b="0" strike="noStrike" spc="-1">
              <a:latin typeface="Times New Roman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Gráfico 40"/>
          <p:cNvGraphicFramePr/>
          <p:nvPr>
            <p:extLst>
              <p:ext uri="{D42A27DB-BD31-4B8C-83A1-F6EECF244321}">
                <p14:modId xmlns:p14="http://schemas.microsoft.com/office/powerpoint/2010/main" val="1362430460"/>
              </p:ext>
            </p:extLst>
          </p:nvPr>
        </p:nvGraphicFramePr>
        <p:xfrm>
          <a:off x="1597733" y="533538"/>
          <a:ext cx="6270860" cy="35111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C3FD2FD3-CA9A-4D44-BB8B-A7835D4B4CE9}"/>
              </a:ext>
            </a:extLst>
          </p:cNvPr>
          <p:cNvSpPr txBox="1"/>
          <p:nvPr/>
        </p:nvSpPr>
        <p:spPr>
          <a:xfrm>
            <a:off x="254000" y="4856480"/>
            <a:ext cx="949599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E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ercentage of t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</a:t>
            </a:r>
            <a:r>
              <a:rPr lang="en-E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 library occupied by each TE order. DHX = Helitron</a:t>
            </a:r>
            <a:r>
              <a:rPr lang="en-ES" sz="1400">
                <a:latin typeface="Times New Roman" panose="02020603050405020304" pitchFamily="18" charset="0"/>
                <a:cs typeface="Times New Roman" panose="02020603050405020304" pitchFamily="18" charset="0"/>
              </a:rPr>
              <a:t>, DTX = TIR-TE </a:t>
            </a:r>
            <a:r>
              <a:rPr lang="en-E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posons, RIX = LINEs,</a:t>
            </a:r>
          </a:p>
          <a:p>
            <a:r>
              <a:rPr lang="en-E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LX = LTR-retrotransposons, RSX = SINEs.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Words>42</Words>
  <Application>Microsoft Macintosh PowerPoint</Application>
  <PresentationFormat>Custom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Symbol</vt:lpstr>
      <vt:lpstr>Times New Roman</vt:lpstr>
      <vt:lpstr>Wingdings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subject/>
  <dc:creator/>
  <dc:description/>
  <cp:lastModifiedBy>Raúl Castanera Andrés</cp:lastModifiedBy>
  <cp:revision>34</cp:revision>
  <dcterms:created xsi:type="dcterms:W3CDTF">2020-07-27T10:45:22Z</dcterms:created>
  <dcterms:modified xsi:type="dcterms:W3CDTF">2020-11-06T11:21:51Z</dcterms:modified>
  <dc:language>en-US</dc:language>
</cp:coreProperties>
</file>